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41" r:id="rId2"/>
    <p:sldId id="60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7" d="100"/>
          <a:sy n="77" d="100"/>
        </p:scale>
        <p:origin x="619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1CAB9E-6682-D3DC-01F2-86D978E118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0A04089-49FE-C9F3-1268-74B802388F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C37381-935D-E134-60B5-2BDC7D5DAE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E58ED-B015-46B0-A8EB-3E1A12B28CEA}" type="datetimeFigureOut">
              <a:rPr lang="en-US" smtClean="0"/>
              <a:t>1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969A24-5CDB-A939-16FC-8807C4DBA8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CC49EB-AFE6-9739-96AE-58192215EA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B8A6F-7597-4825-9161-637FD8AB71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28461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95957D-63C6-0044-A91F-4486D6BDC3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18F99E8-5E89-C64D-65CA-D874BF8DB6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D8D9B4-6F6E-57C6-1909-FF75011C6A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E58ED-B015-46B0-A8EB-3E1A12B28CEA}" type="datetimeFigureOut">
              <a:rPr lang="en-US" smtClean="0"/>
              <a:t>1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82641B-FBE1-2D48-4A7C-8556BCCB11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97877E-C847-C780-48D3-366D414BBC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B8A6F-7597-4825-9161-637FD8AB71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67746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7E83E09-2F00-A961-A96B-13F7EB3463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4E7BB46-6490-AB2F-C721-807CA5F0FD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3AE494-F58D-5678-624D-A627F4B05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E58ED-B015-46B0-A8EB-3E1A12B28CEA}" type="datetimeFigureOut">
              <a:rPr lang="en-US" smtClean="0"/>
              <a:t>1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574350-894D-12B2-E214-0716841227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4DB11F-112E-7F1A-E1CD-1F49C6D0DB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B8A6F-7597-4825-9161-637FD8AB71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180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BD253B-2031-AD0C-D400-82B7000A72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878FDD-EF51-EAC6-5B84-EE21B78312C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3F7A70-7EBF-B544-54E2-719F1B1CEC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E58ED-B015-46B0-A8EB-3E1A12B28CEA}" type="datetimeFigureOut">
              <a:rPr lang="en-US" smtClean="0"/>
              <a:t>1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1B13FF-B2E5-EB6B-F0F5-3BF3401B22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443514-477D-FBD6-6F8F-8346DFB244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B8A6F-7597-4825-9161-637FD8AB71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31495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00DFA6-BA5B-D4D9-1287-8D4029D577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BA1BDD-6328-B2D2-3C39-7B08B7E405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015000-6D90-482A-7C88-1523763A42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E58ED-B015-46B0-A8EB-3E1A12B28CEA}" type="datetimeFigureOut">
              <a:rPr lang="en-US" smtClean="0"/>
              <a:t>1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5801E4-288F-4F88-6BA7-FF7F08DF4F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E6E2F3-DD98-B73B-CE31-220A637F9C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B8A6F-7597-4825-9161-637FD8AB71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58073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46F482-86B2-F5BC-713E-F0DC0F6C5C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D6DC1E-A509-8EDB-A3E3-F56ABF5945E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FA13CF5-82B7-2FE7-2660-763D5D407F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C425D3-7E15-C975-B2B8-FA1283EA95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E58ED-B015-46B0-A8EB-3E1A12B28CEA}" type="datetimeFigureOut">
              <a:rPr lang="en-US" smtClean="0"/>
              <a:t>1/1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2AC00E1-35A7-3100-3023-ED5A7114DE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1185CF-4119-81F5-C9FD-05B8B2183E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B8A6F-7597-4825-9161-637FD8AB71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7000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9EC3C5-2FE7-2A4B-0105-86F5697411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EEE89F-3749-DEB1-7DA3-530F859862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F91B73C-3544-11C5-16B0-215D21E874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6F7F2E9-E5A4-5BFC-6883-3AA7BE739E8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9246A88-78F5-01BE-3073-CB37D16137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06C4F2F-522C-2358-ED17-118DE18A51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E58ED-B015-46B0-A8EB-3E1A12B28CEA}" type="datetimeFigureOut">
              <a:rPr lang="en-US" smtClean="0"/>
              <a:t>1/15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D4A0B94-9CE2-1907-5A78-163B919FF0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AF28A5D-7C02-40FF-7EB2-293EE5D639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B8A6F-7597-4825-9161-637FD8AB71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7845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EF5904-0B7C-D626-E58F-5A043E0CAA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0BBAB24-5334-124F-62D4-4E8AD14C69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E58ED-B015-46B0-A8EB-3E1A12B28CEA}" type="datetimeFigureOut">
              <a:rPr lang="en-US" smtClean="0"/>
              <a:t>1/15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D57843A-5C10-52C6-6BD4-38CFF787E8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96380AB-0AF7-9D50-B5F3-C5977FCFA7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B8A6F-7597-4825-9161-637FD8AB71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67509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FB77375-9E36-A493-0B07-78D07D7265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E58ED-B015-46B0-A8EB-3E1A12B28CEA}" type="datetimeFigureOut">
              <a:rPr lang="en-US" smtClean="0"/>
              <a:t>1/15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6D52A1A-2049-286E-C594-7FE08BD296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87D4444-F54F-9166-D5C4-B40A8368A7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B8A6F-7597-4825-9161-637FD8AB71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2539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38A187-7F8D-62E0-1EEE-77DC1C3015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E34455-D5E1-65C0-EB09-A33E225A8A5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4C5C39C-1472-88D2-3865-EA9CD12218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45C8DC-CF60-D98D-E681-0C598E0B77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E58ED-B015-46B0-A8EB-3E1A12B28CEA}" type="datetimeFigureOut">
              <a:rPr lang="en-US" smtClean="0"/>
              <a:t>1/1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2B5DE4-460A-56C2-BD7B-EC7F21C14B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3CF6D2-CE7D-7BFF-DCAE-36B676645A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B8A6F-7597-4825-9161-637FD8AB71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14320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E4E16A-21D4-12F1-DE08-B084424032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E9210B3-3AE6-32AE-9824-5CF9939BCB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80073D-BFEB-D98D-13F2-EA549F5880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69CF33-09CE-C235-081F-01A9002B18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E58ED-B015-46B0-A8EB-3E1A12B28CEA}" type="datetimeFigureOut">
              <a:rPr lang="en-US" smtClean="0"/>
              <a:t>1/1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1D00E90-0942-1C67-30E5-A5C0E10146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095B09-2CFA-C815-9EF1-FC9AE3EC11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B8A6F-7597-4825-9161-637FD8AB71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5362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9A02D75-D319-ED05-510D-998C4D8992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C2EF08-DB57-308F-A969-534107BD63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8D6C58-EC42-7B6B-5C6B-A0261E95EFB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9E58ED-B015-46B0-A8EB-3E1A12B28CEA}" type="datetimeFigureOut">
              <a:rPr lang="en-US" smtClean="0"/>
              <a:t>1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A95424-8EC6-28B6-7E4E-C73C433A297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E75B65-7EEA-5486-8774-BF09A23F8D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AB8A6F-7597-4825-9161-637FD8AB71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59631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"/><Relationship Id="rId5" Type="http://schemas.openxmlformats.org/officeDocument/2006/relationships/image" Target="../media/image3.e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jpg"/><Relationship Id="rId5" Type="http://schemas.microsoft.com/office/2007/relationships/hdphoto" Target="../media/hdphoto2.wdp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3">
            <a:extLst>
              <a:ext uri="{FF2B5EF4-FFF2-40B4-BE49-F238E27FC236}">
                <a16:creationId xmlns:a16="http://schemas.microsoft.com/office/drawing/2014/main" id="{ABB2A31C-CF36-4EEA-8705-7AD97F12DC2D}"/>
              </a:ext>
            </a:extLst>
          </p:cNvPr>
          <p:cNvSpPr txBox="1"/>
          <p:nvPr/>
        </p:nvSpPr>
        <p:spPr>
          <a:xfrm>
            <a:off x="6743216" y="2962441"/>
            <a:ext cx="881973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sp>
        <p:nvSpPr>
          <p:cNvPr id="3" name="文本框 4">
            <a:extLst>
              <a:ext uri="{FF2B5EF4-FFF2-40B4-BE49-F238E27FC236}">
                <a16:creationId xmlns:a16="http://schemas.microsoft.com/office/drawing/2014/main" id="{6F34E8F7-2F52-4D96-B978-2E676FB2FE02}"/>
              </a:ext>
            </a:extLst>
          </p:cNvPr>
          <p:cNvSpPr txBox="1"/>
          <p:nvPr/>
        </p:nvSpPr>
        <p:spPr>
          <a:xfrm>
            <a:off x="6757710" y="1771552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LR2</a:t>
            </a:r>
          </a:p>
        </p:txBody>
      </p:sp>
      <p:pic>
        <p:nvPicPr>
          <p:cNvPr id="23" name="Picture 22" descr="211216 cxz 10% bactin">
            <a:extLst>
              <a:ext uri="{FF2B5EF4-FFF2-40B4-BE49-F238E27FC236}">
                <a16:creationId xmlns:a16="http://schemas.microsoft.com/office/drawing/2014/main" id="{F308A06F-0312-492D-9167-E1FCF5CA810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106" t="45740" r="6307" b="44600"/>
          <a:stretch/>
        </p:blipFill>
        <p:spPr>
          <a:xfrm rot="-120000" flipH="1">
            <a:off x="1459547" y="2811471"/>
            <a:ext cx="7816095" cy="818012"/>
          </a:xfrm>
          <a:custGeom>
            <a:avLst/>
            <a:gdLst>
              <a:gd name="connsiteX0" fmla="*/ 4298851 w 4317115"/>
              <a:gd name="connsiteY0" fmla="*/ 0 h 673127"/>
              <a:gd name="connsiteX1" fmla="*/ 0 w 4317115"/>
              <a:gd name="connsiteY1" fmla="*/ 150120 h 673127"/>
              <a:gd name="connsiteX2" fmla="*/ 18264 w 4317115"/>
              <a:gd name="connsiteY2" fmla="*/ 673127 h 673127"/>
              <a:gd name="connsiteX3" fmla="*/ 4317115 w 4317115"/>
              <a:gd name="connsiteY3" fmla="*/ 523008 h 67312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4317115" h="673127">
                <a:moveTo>
                  <a:pt x="4298851" y="0"/>
                </a:moveTo>
                <a:lnTo>
                  <a:pt x="0" y="150120"/>
                </a:lnTo>
                <a:lnTo>
                  <a:pt x="18264" y="673127"/>
                </a:lnTo>
                <a:lnTo>
                  <a:pt x="4317115" y="523008"/>
                </a:lnTo>
                <a:close/>
              </a:path>
            </a:pathLst>
          </a:custGeom>
          <a:ln>
            <a:solidFill>
              <a:schemeClr val="tx1"/>
            </a:solidFill>
          </a:ln>
        </p:spPr>
      </p:pic>
      <p:pic>
        <p:nvPicPr>
          <p:cNvPr id="5" name="图片 51" descr="211216  cxz 10% p62_1">
            <a:extLst>
              <a:ext uri="{FF2B5EF4-FFF2-40B4-BE49-F238E27FC236}">
                <a16:creationId xmlns:a16="http://schemas.microsoft.com/office/drawing/2014/main" id="{EB8AA24C-21C6-484F-9D64-3B2CB25B59D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2490" t="46126" r="7674" b="46206"/>
          <a:stretch/>
        </p:blipFill>
        <p:spPr>
          <a:xfrm flipH="1">
            <a:off x="1699591" y="1704339"/>
            <a:ext cx="7494104" cy="49334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45B2DA8B-8407-4BD2-AA78-A156A17B4C78}"/>
              </a:ext>
            </a:extLst>
          </p:cNvPr>
          <p:cNvSpPr txBox="1"/>
          <p:nvPr/>
        </p:nvSpPr>
        <p:spPr>
          <a:xfrm>
            <a:off x="4734878" y="410564"/>
            <a:ext cx="16191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LKBH5-O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B652ABA-0394-426D-95BB-D67A090BC640}"/>
              </a:ext>
            </a:extLst>
          </p:cNvPr>
          <p:cNvSpPr txBox="1"/>
          <p:nvPr/>
        </p:nvSpPr>
        <p:spPr>
          <a:xfrm rot="18839021">
            <a:off x="4358274" y="1011765"/>
            <a:ext cx="1286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1-3#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018871A-63DB-46FB-83AB-85EDC8C5733B}"/>
              </a:ext>
            </a:extLst>
          </p:cNvPr>
          <p:cNvSpPr txBox="1"/>
          <p:nvPr/>
        </p:nvSpPr>
        <p:spPr>
          <a:xfrm>
            <a:off x="2709252" y="410627"/>
            <a:ext cx="1099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Vector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76DAE8A-505A-4123-B17F-135F88A04ADE}"/>
              </a:ext>
            </a:extLst>
          </p:cNvPr>
          <p:cNvSpPr txBox="1"/>
          <p:nvPr/>
        </p:nvSpPr>
        <p:spPr>
          <a:xfrm rot="18839021">
            <a:off x="4948020" y="937872"/>
            <a:ext cx="1286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3#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53327A0-55A0-4640-8525-6C16D416022A}"/>
              </a:ext>
            </a:extLst>
          </p:cNvPr>
          <p:cNvSpPr txBox="1"/>
          <p:nvPr/>
        </p:nvSpPr>
        <p:spPr>
          <a:xfrm rot="18839021">
            <a:off x="5480844" y="940043"/>
            <a:ext cx="1286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2#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6B549CC-06C6-482E-9B34-47CFB284DFB5}"/>
              </a:ext>
            </a:extLst>
          </p:cNvPr>
          <p:cNvSpPr txBox="1"/>
          <p:nvPr/>
        </p:nvSpPr>
        <p:spPr>
          <a:xfrm rot="18839021">
            <a:off x="6114583" y="932138"/>
            <a:ext cx="1286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1#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E586DE23-4DE9-4FB4-A310-B2F86E8226D0}"/>
              </a:ext>
            </a:extLst>
          </p:cNvPr>
          <p:cNvCxnSpPr>
            <a:cxnSpLocks/>
          </p:cNvCxnSpPr>
          <p:nvPr/>
        </p:nvCxnSpPr>
        <p:spPr>
          <a:xfrm>
            <a:off x="3991232" y="795060"/>
            <a:ext cx="2719805" cy="15399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8F839A6E-7754-4479-A963-013DF46C5AE1}"/>
              </a:ext>
            </a:extLst>
          </p:cNvPr>
          <p:cNvCxnSpPr>
            <a:cxnSpLocks/>
          </p:cNvCxnSpPr>
          <p:nvPr/>
        </p:nvCxnSpPr>
        <p:spPr>
          <a:xfrm flipV="1">
            <a:off x="2450092" y="795060"/>
            <a:ext cx="1284873" cy="12893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C01B4452-CC08-4E23-A2A4-3D61BF127F5C}"/>
              </a:ext>
            </a:extLst>
          </p:cNvPr>
          <p:cNvSpPr txBox="1"/>
          <p:nvPr/>
        </p:nvSpPr>
        <p:spPr>
          <a:xfrm rot="18839021">
            <a:off x="3785243" y="926507"/>
            <a:ext cx="1286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C4B0ADF-EA3C-42A9-91B4-13D071E844B2}"/>
              </a:ext>
            </a:extLst>
          </p:cNvPr>
          <p:cNvSpPr txBox="1"/>
          <p:nvPr/>
        </p:nvSpPr>
        <p:spPr>
          <a:xfrm rot="18839021">
            <a:off x="3036469" y="1001623"/>
            <a:ext cx="1286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143A6C9-B9C3-4257-9FA3-19F3E1F8351E}"/>
              </a:ext>
            </a:extLst>
          </p:cNvPr>
          <p:cNvSpPr txBox="1"/>
          <p:nvPr/>
        </p:nvSpPr>
        <p:spPr>
          <a:xfrm rot="18839021">
            <a:off x="2473736" y="978855"/>
            <a:ext cx="1286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C48C029-B9A8-4C4B-904F-2BD0AFBBD969}"/>
              </a:ext>
            </a:extLst>
          </p:cNvPr>
          <p:cNvSpPr txBox="1"/>
          <p:nvPr/>
        </p:nvSpPr>
        <p:spPr>
          <a:xfrm>
            <a:off x="1865929" y="1725084"/>
            <a:ext cx="607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B94C8DB-B62A-440D-8A41-A76885C736A1}"/>
              </a:ext>
            </a:extLst>
          </p:cNvPr>
          <p:cNvSpPr txBox="1"/>
          <p:nvPr/>
        </p:nvSpPr>
        <p:spPr>
          <a:xfrm>
            <a:off x="1918562" y="1200520"/>
            <a:ext cx="811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kDa</a:t>
            </a:r>
            <a:endParaRPr lang="en-US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2929A63-37BB-4389-8B65-EAEA4A1732F4}"/>
              </a:ext>
            </a:extLst>
          </p:cNvPr>
          <p:cNvSpPr txBox="1"/>
          <p:nvPr/>
        </p:nvSpPr>
        <p:spPr>
          <a:xfrm>
            <a:off x="1965737" y="2930572"/>
            <a:ext cx="607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</a:p>
        </p:txBody>
      </p:sp>
      <p:sp>
        <p:nvSpPr>
          <p:cNvPr id="27" name="文本框 4">
            <a:extLst>
              <a:ext uri="{FF2B5EF4-FFF2-40B4-BE49-F238E27FC236}">
                <a16:creationId xmlns:a16="http://schemas.microsoft.com/office/drawing/2014/main" id="{2CC037CE-CCC7-C589-2BB1-38080809F267}"/>
              </a:ext>
            </a:extLst>
          </p:cNvPr>
          <p:cNvSpPr txBox="1"/>
          <p:nvPr/>
        </p:nvSpPr>
        <p:spPr>
          <a:xfrm>
            <a:off x="6774727" y="1111173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LR2</a:t>
            </a:r>
          </a:p>
        </p:txBody>
      </p:sp>
      <p:graphicFrame>
        <p:nvGraphicFramePr>
          <p:cNvPr id="32" name="Object 31">
            <a:extLst>
              <a:ext uri="{FF2B5EF4-FFF2-40B4-BE49-F238E27FC236}">
                <a16:creationId xmlns:a16="http://schemas.microsoft.com/office/drawing/2014/main" id="{46B8AA06-25C4-A2C2-B404-A7DB5E12CE2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554263" y="3623960"/>
          <a:ext cx="5220464" cy="2330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492636" imgH="2330032" progId="Prism9.Document">
                  <p:embed/>
                </p:oleObj>
              </mc:Choice>
              <mc:Fallback>
                <p:oleObj name="Prism 9" r:id="rId4" imgW="3492636" imgH="2330032" progId="Prism9.Document">
                  <p:embed/>
                  <p:pic>
                    <p:nvPicPr>
                      <p:cNvPr id="32" name="Object 31">
                        <a:extLst>
                          <a:ext uri="{FF2B5EF4-FFF2-40B4-BE49-F238E27FC236}">
                            <a16:creationId xmlns:a16="http://schemas.microsoft.com/office/drawing/2014/main" id="{46B8AA06-25C4-A2C2-B404-A7DB5E12CE2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554263" y="3623960"/>
                        <a:ext cx="5220464" cy="2330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2BF99DAB-C0E2-A27A-BB9D-FD5B6E4D61F9}"/>
              </a:ext>
            </a:extLst>
          </p:cNvPr>
          <p:cNvSpPr txBox="1"/>
          <p:nvPr/>
        </p:nvSpPr>
        <p:spPr>
          <a:xfrm>
            <a:off x="1965737" y="2350900"/>
            <a:ext cx="607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</a:p>
        </p:txBody>
      </p:sp>
      <p:sp>
        <p:nvSpPr>
          <p:cNvPr id="14" name="文本框 4">
            <a:extLst>
              <a:ext uri="{FF2B5EF4-FFF2-40B4-BE49-F238E27FC236}">
                <a16:creationId xmlns:a16="http://schemas.microsoft.com/office/drawing/2014/main" id="{FDEAD9A0-70C7-29C4-00BC-A23B12ED4B9E}"/>
              </a:ext>
            </a:extLst>
          </p:cNvPr>
          <p:cNvSpPr txBox="1"/>
          <p:nvPr/>
        </p:nvSpPr>
        <p:spPr>
          <a:xfrm>
            <a:off x="6757709" y="2340154"/>
            <a:ext cx="1069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LKBH5</a:t>
            </a:r>
          </a:p>
        </p:txBody>
      </p:sp>
      <p:pic>
        <p:nvPicPr>
          <p:cNvPr id="16" name="Picture 15" descr="Text&#10;&#10;Description automatically generated">
            <a:extLst>
              <a:ext uri="{FF2B5EF4-FFF2-40B4-BE49-F238E27FC236}">
                <a16:creationId xmlns:a16="http://schemas.microsoft.com/office/drawing/2014/main" id="{553F4F69-0AE4-34C7-A131-2D0C37DB8C9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80" t="57643" r="40964" b="38908"/>
          <a:stretch/>
        </p:blipFill>
        <p:spPr>
          <a:xfrm>
            <a:off x="2409566" y="2309054"/>
            <a:ext cx="6853704" cy="55011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DF221ED3-9979-8882-06F3-EABEE523EB48}"/>
              </a:ext>
            </a:extLst>
          </p:cNvPr>
          <p:cNvSpPr/>
          <p:nvPr/>
        </p:nvSpPr>
        <p:spPr>
          <a:xfrm>
            <a:off x="2387528" y="1636502"/>
            <a:ext cx="4337977" cy="56928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09040244-439F-95C1-0DA2-1929BEA7C103}"/>
              </a:ext>
            </a:extLst>
          </p:cNvPr>
          <p:cNvSpPr/>
          <p:nvPr/>
        </p:nvSpPr>
        <p:spPr>
          <a:xfrm>
            <a:off x="2409566" y="2962068"/>
            <a:ext cx="4337977" cy="56928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31F1286-2B5B-296D-7B30-EC8431BB00FB}"/>
              </a:ext>
            </a:extLst>
          </p:cNvPr>
          <p:cNvSpPr txBox="1"/>
          <p:nvPr/>
        </p:nvSpPr>
        <p:spPr>
          <a:xfrm>
            <a:off x="9380356" y="2399445"/>
            <a:ext cx="3441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LKBH5 cancers</a:t>
            </a:r>
            <a:r>
              <a:rPr lang="zh-CN" altLang="en-US" dirty="0"/>
              <a:t>补实验做的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269007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3">
            <a:extLst>
              <a:ext uri="{FF2B5EF4-FFF2-40B4-BE49-F238E27FC236}">
                <a16:creationId xmlns:a16="http://schemas.microsoft.com/office/drawing/2014/main" id="{73084DB0-01C3-15C2-2250-B49BF5EDC9F0}"/>
              </a:ext>
            </a:extLst>
          </p:cNvPr>
          <p:cNvSpPr txBox="1"/>
          <p:nvPr/>
        </p:nvSpPr>
        <p:spPr>
          <a:xfrm>
            <a:off x="6743216" y="2962441"/>
            <a:ext cx="1210588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-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235A306-0C7E-BCAE-C084-E4BFECF0F81D}"/>
              </a:ext>
            </a:extLst>
          </p:cNvPr>
          <p:cNvSpPr txBox="1"/>
          <p:nvPr/>
        </p:nvSpPr>
        <p:spPr>
          <a:xfrm>
            <a:off x="1965737" y="2930572"/>
            <a:ext cx="607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4496F7D-A290-0BE5-FBD1-1FC546897F6B}"/>
              </a:ext>
            </a:extLst>
          </p:cNvPr>
          <p:cNvSpPr txBox="1"/>
          <p:nvPr/>
        </p:nvSpPr>
        <p:spPr>
          <a:xfrm>
            <a:off x="1965737" y="2350900"/>
            <a:ext cx="607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</a:p>
        </p:txBody>
      </p:sp>
      <p:sp>
        <p:nvSpPr>
          <p:cNvPr id="9" name="文本框 4">
            <a:extLst>
              <a:ext uri="{FF2B5EF4-FFF2-40B4-BE49-F238E27FC236}">
                <a16:creationId xmlns:a16="http://schemas.microsoft.com/office/drawing/2014/main" id="{3C6418D5-398B-A21D-131E-1D11A1E728B7}"/>
              </a:ext>
            </a:extLst>
          </p:cNvPr>
          <p:cNvSpPr txBox="1"/>
          <p:nvPr/>
        </p:nvSpPr>
        <p:spPr>
          <a:xfrm>
            <a:off x="6757709" y="2340154"/>
            <a:ext cx="1069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LKBH5</a:t>
            </a:r>
          </a:p>
        </p:txBody>
      </p:sp>
      <p:pic>
        <p:nvPicPr>
          <p:cNvPr id="10" name="Picture 9" descr="Text&#10;&#10;Description automatically generated">
            <a:extLst>
              <a:ext uri="{FF2B5EF4-FFF2-40B4-BE49-F238E27FC236}">
                <a16:creationId xmlns:a16="http://schemas.microsoft.com/office/drawing/2014/main" id="{82FE6BF8-2952-9405-52DD-399CBC64175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680" t="57643" r="55290" b="39264"/>
          <a:stretch/>
        </p:blipFill>
        <p:spPr>
          <a:xfrm>
            <a:off x="2409566" y="2309055"/>
            <a:ext cx="4293901" cy="49334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A3C2B93D-4273-CB34-758B-CA371103F4E0}"/>
              </a:ext>
            </a:extLst>
          </p:cNvPr>
          <p:cNvSpPr txBox="1"/>
          <p:nvPr/>
        </p:nvSpPr>
        <p:spPr>
          <a:xfrm>
            <a:off x="4626022" y="1033616"/>
            <a:ext cx="16191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LKBH5-O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911F489-FCE4-200C-4291-0BCEEFBF160C}"/>
              </a:ext>
            </a:extLst>
          </p:cNvPr>
          <p:cNvSpPr txBox="1"/>
          <p:nvPr/>
        </p:nvSpPr>
        <p:spPr>
          <a:xfrm rot="18839021">
            <a:off x="4249418" y="1634817"/>
            <a:ext cx="1286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1-3#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B2C180E-0799-CFB6-4141-3543A3F37824}"/>
              </a:ext>
            </a:extLst>
          </p:cNvPr>
          <p:cNvSpPr txBox="1"/>
          <p:nvPr/>
        </p:nvSpPr>
        <p:spPr>
          <a:xfrm>
            <a:off x="2600396" y="1033679"/>
            <a:ext cx="1099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Vector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8889FCF-F8C0-9282-D6EE-6B4D74E6674B}"/>
              </a:ext>
            </a:extLst>
          </p:cNvPr>
          <p:cNvSpPr txBox="1"/>
          <p:nvPr/>
        </p:nvSpPr>
        <p:spPr>
          <a:xfrm rot="18839021">
            <a:off x="4839164" y="1560924"/>
            <a:ext cx="1286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3#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437A169-55BE-62BE-0536-02CDABAEBA48}"/>
              </a:ext>
            </a:extLst>
          </p:cNvPr>
          <p:cNvSpPr txBox="1"/>
          <p:nvPr/>
        </p:nvSpPr>
        <p:spPr>
          <a:xfrm rot="18839021">
            <a:off x="5371988" y="1563095"/>
            <a:ext cx="1286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2#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25A5A93-DFF2-19E6-AE11-4F4414377D1B}"/>
              </a:ext>
            </a:extLst>
          </p:cNvPr>
          <p:cNvSpPr txBox="1"/>
          <p:nvPr/>
        </p:nvSpPr>
        <p:spPr>
          <a:xfrm rot="18839021">
            <a:off x="6005727" y="1555190"/>
            <a:ext cx="1286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1#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2FEDEB04-B485-4CD7-E87B-2AA493E95E44}"/>
              </a:ext>
            </a:extLst>
          </p:cNvPr>
          <p:cNvCxnSpPr>
            <a:cxnSpLocks/>
          </p:cNvCxnSpPr>
          <p:nvPr/>
        </p:nvCxnSpPr>
        <p:spPr>
          <a:xfrm flipV="1">
            <a:off x="2341236" y="1418112"/>
            <a:ext cx="1284873" cy="12893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1A49421F-562E-13A9-058A-F4CEE79447D7}"/>
              </a:ext>
            </a:extLst>
          </p:cNvPr>
          <p:cNvSpPr txBox="1"/>
          <p:nvPr/>
        </p:nvSpPr>
        <p:spPr>
          <a:xfrm rot="18839021">
            <a:off x="3676387" y="1549559"/>
            <a:ext cx="1286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90EB0B7-73E6-21AA-DCA4-AA49CF0AC5F7}"/>
              </a:ext>
            </a:extLst>
          </p:cNvPr>
          <p:cNvSpPr txBox="1"/>
          <p:nvPr/>
        </p:nvSpPr>
        <p:spPr>
          <a:xfrm rot="18839021">
            <a:off x="2927613" y="1624675"/>
            <a:ext cx="1286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5A3032A-3A83-BB4E-99A0-CADF58BF4E17}"/>
              </a:ext>
            </a:extLst>
          </p:cNvPr>
          <p:cNvSpPr txBox="1"/>
          <p:nvPr/>
        </p:nvSpPr>
        <p:spPr>
          <a:xfrm rot="18839021">
            <a:off x="2364880" y="1601907"/>
            <a:ext cx="1286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3" name="文本框 4">
            <a:extLst>
              <a:ext uri="{FF2B5EF4-FFF2-40B4-BE49-F238E27FC236}">
                <a16:creationId xmlns:a16="http://schemas.microsoft.com/office/drawing/2014/main" id="{CEB9C49A-389A-BB4A-9393-6568DBF38E33}"/>
              </a:ext>
            </a:extLst>
          </p:cNvPr>
          <p:cNvSpPr txBox="1"/>
          <p:nvPr/>
        </p:nvSpPr>
        <p:spPr>
          <a:xfrm>
            <a:off x="6695526" y="1734225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LR2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16E0E22-82A3-B4B3-B89C-721EF0626117}"/>
              </a:ext>
            </a:extLst>
          </p:cNvPr>
          <p:cNvCxnSpPr>
            <a:cxnSpLocks/>
          </p:cNvCxnSpPr>
          <p:nvPr/>
        </p:nvCxnSpPr>
        <p:spPr>
          <a:xfrm>
            <a:off x="3988041" y="1414313"/>
            <a:ext cx="252541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29AD169C-6347-C581-03D9-E9D4056237A5}"/>
              </a:ext>
            </a:extLst>
          </p:cNvPr>
          <p:cNvSpPr txBox="1"/>
          <p:nvPr/>
        </p:nvSpPr>
        <p:spPr>
          <a:xfrm>
            <a:off x="7586272" y="4697389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补 </a:t>
            </a:r>
            <a:r>
              <a:rPr lang="en-US" dirty="0" err="1"/>
              <a:t>wyt</a:t>
            </a:r>
            <a:r>
              <a:rPr lang="en-US" dirty="0"/>
              <a:t>\2022-11-17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0F10971-63C8-0597-D221-4AD5B4AC59E8}"/>
              </a:ext>
            </a:extLst>
          </p:cNvPr>
          <p:cNvSpPr txBox="1"/>
          <p:nvPr/>
        </p:nvSpPr>
        <p:spPr>
          <a:xfrm>
            <a:off x="7625189" y="5306397"/>
            <a:ext cx="68422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2022-11-19</a:t>
            </a:r>
          </a:p>
        </p:txBody>
      </p:sp>
      <p:pic>
        <p:nvPicPr>
          <p:cNvPr id="11" name="Picture 10" descr="A picture containing text, screenshot&#10;&#10;Description automatically generated">
            <a:extLst>
              <a:ext uri="{FF2B5EF4-FFF2-40B4-BE49-F238E27FC236}">
                <a16:creationId xmlns:a16="http://schemas.microsoft.com/office/drawing/2014/main" id="{1ABC7FE9-1B32-E025-258B-9C193749A85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466" t="23801" r="22426" b="70438"/>
          <a:stretch/>
        </p:blipFill>
        <p:spPr>
          <a:xfrm rot="21437981">
            <a:off x="2391929" y="2816252"/>
            <a:ext cx="4333226" cy="658798"/>
          </a:xfrm>
          <a:custGeom>
            <a:avLst/>
            <a:gdLst>
              <a:gd name="connsiteX0" fmla="*/ 23807 w 4415112"/>
              <a:gd name="connsiteY0" fmla="*/ 0 h 711883"/>
              <a:gd name="connsiteX1" fmla="*/ 4415112 w 4415112"/>
              <a:gd name="connsiteY1" fmla="*/ 207113 h 711883"/>
              <a:gd name="connsiteX2" fmla="*/ 4391305 w 4415112"/>
              <a:gd name="connsiteY2" fmla="*/ 711883 h 711883"/>
              <a:gd name="connsiteX3" fmla="*/ 0 w 4415112"/>
              <a:gd name="connsiteY3" fmla="*/ 504770 h 71188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4415112" h="711883">
                <a:moveTo>
                  <a:pt x="23807" y="0"/>
                </a:moveTo>
                <a:lnTo>
                  <a:pt x="4415112" y="207113"/>
                </a:lnTo>
                <a:lnTo>
                  <a:pt x="4391305" y="711883"/>
                </a:lnTo>
                <a:lnTo>
                  <a:pt x="0" y="504770"/>
                </a:lnTo>
                <a:close/>
              </a:path>
            </a:pathLst>
          </a:custGeom>
          <a:ln>
            <a:solidFill>
              <a:schemeClr val="tx1"/>
            </a:solidFill>
          </a:ln>
        </p:spPr>
      </p:pic>
      <p:pic>
        <p:nvPicPr>
          <p:cNvPr id="3" name="Picture 2" descr="A picture containing indoor&#10;&#10;Description automatically generated">
            <a:extLst>
              <a:ext uri="{FF2B5EF4-FFF2-40B4-BE49-F238E27FC236}">
                <a16:creationId xmlns:a16="http://schemas.microsoft.com/office/drawing/2014/main" id="{12274656-1304-0997-0AB6-58B70981242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58" t="46126" r="33857" b="45355"/>
          <a:stretch/>
        </p:blipFill>
        <p:spPr>
          <a:xfrm>
            <a:off x="2373867" y="3468281"/>
            <a:ext cx="4329599" cy="587317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04177CD3-56B2-2814-0D5B-5BB1434B7273}"/>
              </a:ext>
            </a:extLst>
          </p:cNvPr>
          <p:cNvSpPr txBox="1"/>
          <p:nvPr/>
        </p:nvSpPr>
        <p:spPr>
          <a:xfrm>
            <a:off x="6743216" y="3599397"/>
            <a:ext cx="1210588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-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2FD09E8-995A-2C51-4089-266D0B768C2D}"/>
              </a:ext>
            </a:extLst>
          </p:cNvPr>
          <p:cNvSpPr txBox="1"/>
          <p:nvPr/>
        </p:nvSpPr>
        <p:spPr>
          <a:xfrm>
            <a:off x="1906700" y="3560469"/>
            <a:ext cx="607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</p:spTree>
    <p:extLst>
      <p:ext uri="{BB962C8B-B14F-4D97-AF65-F5344CB8AC3E}">
        <p14:creationId xmlns:p14="http://schemas.microsoft.com/office/powerpoint/2010/main" val="39764208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52</Words>
  <Application>Microsoft Office PowerPoint</Application>
  <PresentationFormat>Widescreen</PresentationFormat>
  <Paragraphs>36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e jing</dc:creator>
  <cp:lastModifiedBy>ye jing</cp:lastModifiedBy>
  <cp:revision>3</cp:revision>
  <dcterms:created xsi:type="dcterms:W3CDTF">2023-01-15T04:51:53Z</dcterms:created>
  <dcterms:modified xsi:type="dcterms:W3CDTF">2023-01-15T05:09:16Z</dcterms:modified>
</cp:coreProperties>
</file>